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1" r:id="rId3"/>
    <p:sldId id="260" r:id="rId4"/>
    <p:sldId id="258" r:id="rId5"/>
    <p:sldId id="263" r:id="rId6"/>
    <p:sldId id="264" r:id="rId7"/>
    <p:sldId id="262" r:id="rId8"/>
    <p:sldId id="259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CC67DB-900F-AF54-BBA4-6E5C704AC4A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7A6862E-364F-9EDD-89C0-D126EDE9E08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348654-40F3-6D88-06CB-4B1E0999D9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DF1B6-17F1-4F45-8556-6FA0F466AA92}" type="datetimeFigureOut">
              <a:rPr lang="en-GB" smtClean="0"/>
              <a:t>24/1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9CEDF0-C6F9-B5CA-CE6B-4AF8BDD8D1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E935DD-36DE-E7B8-D5EC-BF8DC82C2E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CF689-2DA4-42B3-BD9E-4DDCE0106A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56371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E38791-86D9-0488-04B5-7421C32CFE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BD92C1-865E-3900-CD9F-5A4DCC658F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3CC93C-2732-D815-805E-9C61FEFBF2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DF1B6-17F1-4F45-8556-6FA0F466AA92}" type="datetimeFigureOut">
              <a:rPr lang="en-GB" smtClean="0"/>
              <a:t>24/1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17DE78-AC88-CF5F-3E10-C71C716B12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5F0F96-FAE2-7766-1D4F-B0EF2A0DBB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CF689-2DA4-42B3-BD9E-4DDCE0106A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9932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D79034B-294B-27FD-7ACD-ECF9D3D67E0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FBCE271-BE93-DFD4-DAC0-F70846C793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D71774-A7EC-C2CC-AA18-C4DF314CBC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DF1B6-17F1-4F45-8556-6FA0F466AA92}" type="datetimeFigureOut">
              <a:rPr lang="en-GB" smtClean="0"/>
              <a:t>24/1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4E2B34-394C-1F17-FBC9-5FBB8B89EB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0E83A9-3EEB-8BA5-CCC5-27E7A60124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CF689-2DA4-42B3-BD9E-4DDCE0106A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84114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F61877-FFCA-226E-FCD6-23E2D2484B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82EF768-E475-A1A4-77B3-0A165FBEAC8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DFC962-6050-F6A7-D4C0-ABCAD4A6D0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DF1B6-17F1-4F45-8556-6FA0F466AA92}" type="datetimeFigureOut">
              <a:rPr lang="en-GB" smtClean="0"/>
              <a:t>24/1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FFE285-0A4B-950A-00A0-5332049773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22D6C3-63D6-F3D0-8F33-ED13040D49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CF689-2DA4-42B3-BD9E-4DDCE0106A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40524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892281-0D04-CEBF-8F97-18D4E3B558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18C0397-5DF2-EBED-7323-098CB5A4E3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523D9F-EDB2-9DCA-B03F-060178B2C0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DF1B6-17F1-4F45-8556-6FA0F466AA92}" type="datetimeFigureOut">
              <a:rPr lang="en-GB" smtClean="0"/>
              <a:t>24/1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D9E72D-973C-745A-17D5-64140BB445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DB2AD1-007C-5191-6CA1-84DC31DDA8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CF689-2DA4-42B3-BD9E-4DDCE0106A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47500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FBC9F7-2C68-EF20-D7C6-1DB19FE3F7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20A9D1-E244-41BD-309C-D4366E3991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C1B6F0A-7C79-767E-6CB3-A65FE82314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069DFDC-E189-38F0-DEE5-12148C6727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DF1B6-17F1-4F45-8556-6FA0F466AA92}" type="datetimeFigureOut">
              <a:rPr lang="en-GB" smtClean="0"/>
              <a:t>24/1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9DC898-EF4D-6826-27CA-65292E0E70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07E1C0-F6C8-B09B-7882-8E3154EF69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CF689-2DA4-42B3-BD9E-4DDCE0106A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02308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C02D2A-6BC4-6345-2E39-C4327610BF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070E43-E99F-DE37-19DA-0245A05C41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F8C15D2-AD3D-4FF2-2F95-8750112483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D7924F9-F9BF-BC8A-A12A-FAA3F976004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4777A0C-53DC-92B6-B222-9BEE25FB413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345DCF0-4B6C-8B97-692C-714137EE5D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DF1B6-17F1-4F45-8556-6FA0F466AA92}" type="datetimeFigureOut">
              <a:rPr lang="en-GB" smtClean="0"/>
              <a:t>24/12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2AD247B-2EDF-60B3-2E59-9834DB9262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195B5D0-902F-0A05-2BBF-FC256B5092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CF689-2DA4-42B3-BD9E-4DDCE0106A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76374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175BE4-4899-89AE-B0BE-9FB049F089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084D320-0E45-1D68-8606-721A74062D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DF1B6-17F1-4F45-8556-6FA0F466AA92}" type="datetimeFigureOut">
              <a:rPr lang="en-GB" smtClean="0"/>
              <a:t>24/12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8620E61-8550-9CD5-536C-F0F6F0C93A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B4DC95A-AE77-76F6-29CC-BE6345C7BC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CF689-2DA4-42B3-BD9E-4DDCE0106A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75680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569AF02-5133-3B62-F7BE-CAA8671465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DF1B6-17F1-4F45-8556-6FA0F466AA92}" type="datetimeFigureOut">
              <a:rPr lang="en-GB" smtClean="0"/>
              <a:t>24/12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41949E0-29B7-820A-A39C-D738336289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ABD1206-F826-3900-2B55-E560739C94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CF689-2DA4-42B3-BD9E-4DDCE0106A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30672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FE7B21-1E9D-343D-6CF7-6A4DA1C2BF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D1F096-8E99-B0E5-57A4-7D9D10E52C1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8C7E8C7-4F9B-2E4F-FEF4-2A37E087CC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2EFB05-FFAE-9CFB-BAAE-D7F132AA8A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DF1B6-17F1-4F45-8556-6FA0F466AA92}" type="datetimeFigureOut">
              <a:rPr lang="en-GB" smtClean="0"/>
              <a:t>24/1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97462C1-84B5-1A56-A4DF-32BD0E200C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7E9AFC2-3667-1559-DF32-667A5759E1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CF689-2DA4-42B3-BD9E-4DDCE0106A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5935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7E2FF1-EC9A-B412-C23C-0A5DB9CFE4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2812DF8-E87F-2DBD-A73B-FDED09105EA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8C1A49-FB1D-324F-FB4D-C6AFC38E7F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208C028-E064-4981-4A4C-B251C3A7F3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DF1B6-17F1-4F45-8556-6FA0F466AA92}" type="datetimeFigureOut">
              <a:rPr lang="en-GB" smtClean="0"/>
              <a:t>24/1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508C3FF-1495-EAF8-FE38-EEC058C619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66F1C7-9AD3-1416-3C56-B3D02E37F6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CF689-2DA4-42B3-BD9E-4DDCE0106A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59108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78E46C8-CF50-5354-8B6E-AF7D6A5BBE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D038F8C-5EE7-C2A0-D2DC-27B479E68D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42F715-3B46-942E-302E-D165353D682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CDF1B6-17F1-4F45-8556-6FA0F466AA92}" type="datetimeFigureOut">
              <a:rPr lang="en-GB" smtClean="0"/>
              <a:t>24/1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02DBE7-758C-3E32-2AB4-9BF9D7B1F30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5E3CF7-C736-06B6-5130-3AC9F20ACFE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3CF689-2DA4-42B3-BD9E-4DDCE0106A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19824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3CE8DF94-AE9F-949C-2689-7B4C9C1E01B0}"/>
              </a:ext>
            </a:extLst>
          </p:cNvPr>
          <p:cNvSpPr txBox="1"/>
          <p:nvPr/>
        </p:nvSpPr>
        <p:spPr>
          <a:xfrm>
            <a:off x="406711" y="2017527"/>
            <a:ext cx="15427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+mj-lt"/>
              </a:rPr>
              <a:t>Phospho-PYK2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FE703298-A2FF-423B-CB3B-327D10ED247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5715" r="26095" b="26278"/>
          <a:stretch/>
        </p:blipFill>
        <p:spPr>
          <a:xfrm>
            <a:off x="2214694" y="843286"/>
            <a:ext cx="3556932" cy="3812512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93E0548F-E087-0BC1-05B7-60B87918E9E6}"/>
              </a:ext>
            </a:extLst>
          </p:cNvPr>
          <p:cNvSpPr txBox="1"/>
          <p:nvPr/>
        </p:nvSpPr>
        <p:spPr>
          <a:xfrm>
            <a:off x="2357733" y="1212617"/>
            <a:ext cx="38524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  0         10        30         60        90        120 (min)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909F9E7C-1C70-0F56-3CC0-15FE62D2231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rcRect l="46592" t="15782" r="19581" b="-15412"/>
          <a:stretch/>
        </p:blipFill>
        <p:spPr>
          <a:xfrm>
            <a:off x="5914665" y="922789"/>
            <a:ext cx="2799553" cy="3984771"/>
          </a:xfrm>
          <a:prstGeom prst="rect">
            <a:avLst/>
          </a:prstGeom>
          <a:ln>
            <a:noFill/>
          </a:ln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9086BB40-7F70-A1B8-A18B-F677A48A208D}"/>
              </a:ext>
            </a:extLst>
          </p:cNvPr>
          <p:cNvSpPr txBox="1"/>
          <p:nvPr/>
        </p:nvSpPr>
        <p:spPr>
          <a:xfrm>
            <a:off x="5898313" y="1212616"/>
            <a:ext cx="38524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  0        10      30      60      90        120 (min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928BB7E-FEBD-44E9-3123-A023F8757056}"/>
              </a:ext>
            </a:extLst>
          </p:cNvPr>
          <p:cNvSpPr txBox="1"/>
          <p:nvPr/>
        </p:nvSpPr>
        <p:spPr>
          <a:xfrm>
            <a:off x="8910723" y="1942026"/>
            <a:ext cx="643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+mj-lt"/>
              </a:rPr>
              <a:t>PYK2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EB1958A0-621E-9533-9133-0279597AC7F2}"/>
              </a:ext>
            </a:extLst>
          </p:cNvPr>
          <p:cNvCxnSpPr>
            <a:stCxn id="14" idx="1"/>
          </p:cNvCxnSpPr>
          <p:nvPr/>
        </p:nvCxnSpPr>
        <p:spPr>
          <a:xfrm flipH="1">
            <a:off x="8714218" y="2126692"/>
            <a:ext cx="19650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8243F73E-1587-323F-4515-A6F725F96FEE}"/>
              </a:ext>
            </a:extLst>
          </p:cNvPr>
          <p:cNvCxnSpPr>
            <a:stCxn id="8" idx="3"/>
          </p:cNvCxnSpPr>
          <p:nvPr/>
        </p:nvCxnSpPr>
        <p:spPr>
          <a:xfrm>
            <a:off x="1949506" y="2202193"/>
            <a:ext cx="33035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749910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0734B7C-DF65-402D-2590-689FBE5F21D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6511" t="33408" r="26913"/>
          <a:stretch/>
        </p:blipFill>
        <p:spPr>
          <a:xfrm>
            <a:off x="2625754" y="2092777"/>
            <a:ext cx="3437779" cy="344376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9FD229B-F3A2-D850-4EC1-28016EC08025}"/>
              </a:ext>
            </a:extLst>
          </p:cNvPr>
          <p:cNvSpPr txBox="1"/>
          <p:nvPr/>
        </p:nvSpPr>
        <p:spPr>
          <a:xfrm>
            <a:off x="843137" y="2975994"/>
            <a:ext cx="16014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+mj-lt"/>
              </a:rPr>
              <a:t>Phospho-STAT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3EE863A-5F19-E856-68E3-877096E0E635}"/>
              </a:ext>
            </a:extLst>
          </p:cNvPr>
          <p:cNvSpPr txBox="1"/>
          <p:nvPr/>
        </p:nvSpPr>
        <p:spPr>
          <a:xfrm>
            <a:off x="2917425" y="1492178"/>
            <a:ext cx="34377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  0        10      30        60       90      120 (min)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187875A7-8F6F-C538-04C3-A484658DCC3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6283" r="27140" b="31152"/>
          <a:stretch/>
        </p:blipFill>
        <p:spPr>
          <a:xfrm>
            <a:off x="6266576" y="1976125"/>
            <a:ext cx="3437779" cy="3560418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554AA9D-7AAE-0BF4-274A-A4DD846B69AD}"/>
              </a:ext>
            </a:extLst>
          </p:cNvPr>
          <p:cNvSpPr txBox="1"/>
          <p:nvPr/>
        </p:nvSpPr>
        <p:spPr>
          <a:xfrm>
            <a:off x="6469619" y="1785000"/>
            <a:ext cx="35971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  0        10        30         60        90        120 (min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2DF64A5-3EB6-B5E9-4B4C-2AFFDC6883A0}"/>
              </a:ext>
            </a:extLst>
          </p:cNvPr>
          <p:cNvSpPr txBox="1"/>
          <p:nvPr/>
        </p:nvSpPr>
        <p:spPr>
          <a:xfrm>
            <a:off x="10066789" y="2799717"/>
            <a:ext cx="7229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+mj-lt"/>
              </a:rPr>
              <a:t>STAT1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0541B774-D907-31D5-E97F-B9B09EAF3D08}"/>
              </a:ext>
            </a:extLst>
          </p:cNvPr>
          <p:cNvCxnSpPr/>
          <p:nvPr/>
        </p:nvCxnSpPr>
        <p:spPr>
          <a:xfrm>
            <a:off x="2323750" y="3160660"/>
            <a:ext cx="42783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560288E9-C7C5-B988-342D-AFA7D89708FD}"/>
              </a:ext>
            </a:extLst>
          </p:cNvPr>
          <p:cNvCxnSpPr>
            <a:stCxn id="9" idx="1"/>
          </p:cNvCxnSpPr>
          <p:nvPr/>
        </p:nvCxnSpPr>
        <p:spPr>
          <a:xfrm flipH="1">
            <a:off x="9622172" y="2984383"/>
            <a:ext cx="44461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450471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86B36B5-AA84-2592-D4F0-F83322E21E9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514" r="22495" b="18768"/>
          <a:stretch/>
        </p:blipFill>
        <p:spPr>
          <a:xfrm>
            <a:off x="3331067" y="1710291"/>
            <a:ext cx="2764933" cy="286170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9A5B8AC-DF26-1833-BD5A-7B8EE5C8A772}"/>
              </a:ext>
            </a:extLst>
          </p:cNvPr>
          <p:cNvSpPr txBox="1"/>
          <p:nvPr/>
        </p:nvSpPr>
        <p:spPr>
          <a:xfrm>
            <a:off x="3331067" y="1855520"/>
            <a:ext cx="32387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  0       10       30      60       90     120 (min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6718AE8D-D644-B59A-7AE0-61DF56D2F9E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9839" t="28121" r="40895" b="24826"/>
          <a:stretch/>
        </p:blipFill>
        <p:spPr>
          <a:xfrm>
            <a:off x="6767150" y="1710291"/>
            <a:ext cx="2348917" cy="286171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184526C-C044-6BD4-3659-DA8750AD2390}"/>
              </a:ext>
            </a:extLst>
          </p:cNvPr>
          <p:cNvSpPr txBox="1"/>
          <p:nvPr/>
        </p:nvSpPr>
        <p:spPr>
          <a:xfrm>
            <a:off x="6722409" y="1710291"/>
            <a:ext cx="32387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  0       10      30    60     90    120 (min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2A0EE8C-3D3F-9423-28DF-E54F4EE0A6FA}"/>
              </a:ext>
            </a:extLst>
          </p:cNvPr>
          <p:cNvSpPr txBox="1"/>
          <p:nvPr/>
        </p:nvSpPr>
        <p:spPr>
          <a:xfrm>
            <a:off x="1268737" y="2856286"/>
            <a:ext cx="172675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+mj-lt"/>
              </a:rPr>
              <a:t>Phospho-GSK3</a:t>
            </a:r>
            <a:r>
              <a:rPr lang="el-GR" dirty="0">
                <a:latin typeface="+mj-lt"/>
              </a:rPr>
              <a:t>α</a:t>
            </a:r>
            <a:endParaRPr lang="en-GB" dirty="0">
              <a:latin typeface="+mj-lt"/>
            </a:endParaRPr>
          </a:p>
          <a:p>
            <a:r>
              <a:rPr lang="en-GB" dirty="0">
                <a:latin typeface="+mj-lt"/>
              </a:rPr>
              <a:t>Phospho-GSK3</a:t>
            </a:r>
            <a:r>
              <a:rPr lang="el-GR" dirty="0">
                <a:latin typeface="+mj-lt"/>
              </a:rPr>
              <a:t>β</a:t>
            </a:r>
            <a:endParaRPr lang="en-GB" dirty="0">
              <a:latin typeface="+mj-lt"/>
            </a:endParaRP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051A3BA7-C265-2A58-64EA-CA198E66C4FC}"/>
              </a:ext>
            </a:extLst>
          </p:cNvPr>
          <p:cNvCxnSpPr/>
          <p:nvPr/>
        </p:nvCxnSpPr>
        <p:spPr>
          <a:xfrm>
            <a:off x="2857267" y="3040953"/>
            <a:ext cx="473800" cy="7136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138F342B-B603-C6EA-666C-05A75CF509DA}"/>
              </a:ext>
            </a:extLst>
          </p:cNvPr>
          <p:cNvCxnSpPr/>
          <p:nvPr/>
        </p:nvCxnSpPr>
        <p:spPr>
          <a:xfrm flipV="1">
            <a:off x="2857267" y="3288484"/>
            <a:ext cx="473800" cy="6711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B8E66C5E-904E-6ED9-FB07-9B2A3B1C98E0}"/>
              </a:ext>
            </a:extLst>
          </p:cNvPr>
          <p:cNvSpPr txBox="1"/>
          <p:nvPr/>
        </p:nvSpPr>
        <p:spPr>
          <a:xfrm>
            <a:off x="9559427" y="2885592"/>
            <a:ext cx="79541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+mj-lt"/>
              </a:rPr>
              <a:t>GSK3</a:t>
            </a:r>
            <a:r>
              <a:rPr lang="el-GR" dirty="0">
                <a:latin typeface="+mj-lt"/>
              </a:rPr>
              <a:t>α</a:t>
            </a:r>
            <a:endParaRPr lang="en-GB" dirty="0">
              <a:latin typeface="+mj-lt"/>
            </a:endParaRPr>
          </a:p>
          <a:p>
            <a:r>
              <a:rPr lang="en-GB" dirty="0">
                <a:latin typeface="+mj-lt"/>
              </a:rPr>
              <a:t>GSK3</a:t>
            </a:r>
            <a:r>
              <a:rPr lang="el-GR" dirty="0">
                <a:latin typeface="+mj-lt"/>
              </a:rPr>
              <a:t>β</a:t>
            </a:r>
            <a:endParaRPr lang="en-GB" dirty="0">
              <a:latin typeface="+mj-lt"/>
            </a:endParaRP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4FB29B2F-B142-760E-4EFE-66A052BEBEDC}"/>
              </a:ext>
            </a:extLst>
          </p:cNvPr>
          <p:cNvCxnSpPr>
            <a:cxnSpLocks/>
          </p:cNvCxnSpPr>
          <p:nvPr/>
        </p:nvCxnSpPr>
        <p:spPr>
          <a:xfrm flipH="1">
            <a:off x="9116067" y="3040953"/>
            <a:ext cx="438994" cy="13849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7A6837D0-6B9E-93F0-7A8B-D0394C14F4AE}"/>
              </a:ext>
            </a:extLst>
          </p:cNvPr>
          <p:cNvCxnSpPr/>
          <p:nvPr/>
        </p:nvCxnSpPr>
        <p:spPr>
          <a:xfrm flipH="1">
            <a:off x="9160808" y="3355596"/>
            <a:ext cx="39861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266024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54CD229-208E-D061-AF7D-2A66D8EC1EB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5175" t="14631" r="30026" b="35846"/>
          <a:stretch/>
        </p:blipFill>
        <p:spPr>
          <a:xfrm>
            <a:off x="3573710" y="1574755"/>
            <a:ext cx="1830463" cy="256101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A19864A-BF9D-9AFE-D63E-34069BDB286E}"/>
              </a:ext>
            </a:extLst>
          </p:cNvPr>
          <p:cNvSpPr txBox="1"/>
          <p:nvPr/>
        </p:nvSpPr>
        <p:spPr>
          <a:xfrm>
            <a:off x="1441134" y="2753855"/>
            <a:ext cx="16014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+mj-lt"/>
              </a:rPr>
              <a:t>Phospho-STAT3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0416918-C682-2296-1580-6EB1D469E5BF}"/>
              </a:ext>
            </a:extLst>
          </p:cNvPr>
          <p:cNvSpPr txBox="1"/>
          <p:nvPr/>
        </p:nvSpPr>
        <p:spPr>
          <a:xfrm>
            <a:off x="8633238" y="2946910"/>
            <a:ext cx="7229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+mj-lt"/>
              </a:rPr>
              <a:t>STAT3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C31AD21B-68F0-A446-6B81-44EC27BAEFB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6892" t="16997" r="31504" b="31841"/>
          <a:stretch/>
        </p:blipFill>
        <p:spPr>
          <a:xfrm>
            <a:off x="6157519" y="1574755"/>
            <a:ext cx="2257917" cy="256101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3BF362D-9870-544D-6C60-EA08FB0E62C1}"/>
              </a:ext>
            </a:extLst>
          </p:cNvPr>
          <p:cNvSpPr txBox="1"/>
          <p:nvPr/>
        </p:nvSpPr>
        <p:spPr>
          <a:xfrm>
            <a:off x="3402551" y="2132357"/>
            <a:ext cx="32387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  0     10    30   60   90   120 (min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57EBAD3-F840-50ED-9704-D62BBD54EE7C}"/>
              </a:ext>
            </a:extLst>
          </p:cNvPr>
          <p:cNvSpPr txBox="1"/>
          <p:nvPr/>
        </p:nvSpPr>
        <p:spPr>
          <a:xfrm>
            <a:off x="6037567" y="2140745"/>
            <a:ext cx="32387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  0      10     30     60    90    120 (min)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4B8CC2C6-2951-FDE8-8636-D539371A7886}"/>
              </a:ext>
            </a:extLst>
          </p:cNvPr>
          <p:cNvCxnSpPr>
            <a:stCxn id="4" idx="3"/>
          </p:cNvCxnSpPr>
          <p:nvPr/>
        </p:nvCxnSpPr>
        <p:spPr>
          <a:xfrm>
            <a:off x="3042534" y="2938521"/>
            <a:ext cx="447286" cy="6473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F9322387-A354-AD93-69AC-A3D2C6075A63}"/>
              </a:ext>
            </a:extLst>
          </p:cNvPr>
          <p:cNvCxnSpPr>
            <a:stCxn id="5" idx="1"/>
          </p:cNvCxnSpPr>
          <p:nvPr/>
        </p:nvCxnSpPr>
        <p:spPr>
          <a:xfrm flipH="1">
            <a:off x="8415436" y="3131576"/>
            <a:ext cx="21780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647493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86C4A26-7FDE-01F9-7CAC-C58CE0DAEB2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8954" t="22764" r="39388" b="13827"/>
          <a:stretch/>
        </p:blipFill>
        <p:spPr>
          <a:xfrm>
            <a:off x="3491518" y="1613146"/>
            <a:ext cx="2640563" cy="385647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A72DAB9-F93C-F74D-D431-90AEB8F41BF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7844" t="11275" r="38004" b="24034"/>
          <a:stretch/>
        </p:blipFill>
        <p:spPr>
          <a:xfrm>
            <a:off x="6233020" y="1535184"/>
            <a:ext cx="2944537" cy="3934438"/>
          </a:xfrm>
          <a:prstGeom prst="rect">
            <a:avLst/>
          </a:prstGeom>
        </p:spPr>
      </p:pic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7B2D13B6-B1D1-DC0B-0121-B6A987AD36F8}"/>
              </a:ext>
            </a:extLst>
          </p:cNvPr>
          <p:cNvCxnSpPr/>
          <p:nvPr/>
        </p:nvCxnSpPr>
        <p:spPr>
          <a:xfrm>
            <a:off x="2978092" y="2885813"/>
            <a:ext cx="57884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2A1B03BE-5775-0DCB-EC09-CB6864AA0B88}"/>
              </a:ext>
            </a:extLst>
          </p:cNvPr>
          <p:cNvSpPr txBox="1"/>
          <p:nvPr/>
        </p:nvSpPr>
        <p:spPr>
          <a:xfrm>
            <a:off x="1471648" y="2701147"/>
            <a:ext cx="15427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+mj-lt"/>
              </a:rPr>
              <a:t>Phospho-PYK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2C8DC79-D46E-942C-A797-3DF51936D466}"/>
              </a:ext>
            </a:extLst>
          </p:cNvPr>
          <p:cNvSpPr txBox="1"/>
          <p:nvPr/>
        </p:nvSpPr>
        <p:spPr>
          <a:xfrm>
            <a:off x="9278496" y="2885813"/>
            <a:ext cx="643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+mj-lt"/>
              </a:rPr>
              <a:t>PYK2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4CF12F37-F1DD-0E16-4904-8E94D2EF63A5}"/>
              </a:ext>
            </a:extLst>
          </p:cNvPr>
          <p:cNvCxnSpPr>
            <a:stCxn id="9" idx="1"/>
          </p:cNvCxnSpPr>
          <p:nvPr/>
        </p:nvCxnSpPr>
        <p:spPr>
          <a:xfrm flipH="1">
            <a:off x="9081991" y="3070479"/>
            <a:ext cx="19650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6CBF06F2-D5FE-9FEF-1340-EDD4E12900C5}"/>
              </a:ext>
            </a:extLst>
          </p:cNvPr>
          <p:cNvSpPr txBox="1"/>
          <p:nvPr/>
        </p:nvSpPr>
        <p:spPr>
          <a:xfrm rot="18594304">
            <a:off x="3249598" y="1227437"/>
            <a:ext cx="13341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C</a:t>
            </a:r>
            <a:r>
              <a:rPr lang="en-US" altLang="zh-CN" sz="1600" b="1" dirty="0"/>
              <a:t>on</a:t>
            </a:r>
            <a:endParaRPr lang="en-GB" sz="1600" b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025DEFD-C94C-5DF0-A714-F0AF0BA217E4}"/>
              </a:ext>
            </a:extLst>
          </p:cNvPr>
          <p:cNvSpPr txBox="1"/>
          <p:nvPr/>
        </p:nvSpPr>
        <p:spPr>
          <a:xfrm rot="18721435">
            <a:off x="3697864" y="1143114"/>
            <a:ext cx="15919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Gal-3</a:t>
            </a:r>
            <a:endParaRPr lang="en-GB" sz="1600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F591B7F-3310-5238-B78D-025839ADBEFE}"/>
              </a:ext>
            </a:extLst>
          </p:cNvPr>
          <p:cNvSpPr txBox="1"/>
          <p:nvPr/>
        </p:nvSpPr>
        <p:spPr>
          <a:xfrm rot="18594304">
            <a:off x="4173438" y="1316088"/>
            <a:ext cx="13146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Gal-3+S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A897C3A-D534-0587-72B3-D1BC280EF273}"/>
              </a:ext>
            </a:extLst>
          </p:cNvPr>
          <p:cNvSpPr txBox="1"/>
          <p:nvPr/>
        </p:nvSpPr>
        <p:spPr>
          <a:xfrm rot="18594304">
            <a:off x="4702131" y="1336618"/>
            <a:ext cx="10755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sz="1600" b="1" dirty="0"/>
              <a:t>Gal-3+PF</a:t>
            </a:r>
            <a:endParaRPr lang="en-GB" sz="1600" b="1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5F76309-A65B-1B58-6030-EA0878B40410}"/>
              </a:ext>
            </a:extLst>
          </p:cNvPr>
          <p:cNvSpPr txBox="1"/>
          <p:nvPr/>
        </p:nvSpPr>
        <p:spPr>
          <a:xfrm rot="18594304">
            <a:off x="5232746" y="1155735"/>
            <a:ext cx="10872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SB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1EE5DBE-0A51-3424-E5B7-2934478CE6C3}"/>
              </a:ext>
            </a:extLst>
          </p:cNvPr>
          <p:cNvSpPr txBox="1"/>
          <p:nvPr/>
        </p:nvSpPr>
        <p:spPr>
          <a:xfrm rot="18594304">
            <a:off x="5697602" y="1162048"/>
            <a:ext cx="10708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sz="1600" b="1" dirty="0"/>
              <a:t>PF</a:t>
            </a:r>
            <a:endParaRPr lang="en-GB" sz="1600" b="1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2A9A28D-5162-2AB7-7E42-AA81A703525E}"/>
              </a:ext>
            </a:extLst>
          </p:cNvPr>
          <p:cNvSpPr txBox="1"/>
          <p:nvPr/>
        </p:nvSpPr>
        <p:spPr>
          <a:xfrm rot="18594304">
            <a:off x="6321565" y="989940"/>
            <a:ext cx="13341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C</a:t>
            </a:r>
            <a:r>
              <a:rPr lang="en-US" altLang="zh-CN" sz="1600" b="1" dirty="0"/>
              <a:t>on</a:t>
            </a:r>
            <a:endParaRPr lang="en-GB" sz="1600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98E3C16-9313-3573-125E-AED9054A9207}"/>
              </a:ext>
            </a:extLst>
          </p:cNvPr>
          <p:cNvSpPr txBox="1"/>
          <p:nvPr/>
        </p:nvSpPr>
        <p:spPr>
          <a:xfrm rot="18721435">
            <a:off x="6769831" y="905617"/>
            <a:ext cx="15919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Gal-3</a:t>
            </a:r>
            <a:endParaRPr lang="en-GB" sz="1600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F1863C2-DF51-2953-EDE1-DA8997C49AF4}"/>
              </a:ext>
            </a:extLst>
          </p:cNvPr>
          <p:cNvSpPr txBox="1"/>
          <p:nvPr/>
        </p:nvSpPr>
        <p:spPr>
          <a:xfrm rot="18594304">
            <a:off x="7245405" y="1078591"/>
            <a:ext cx="13146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Gal-3+SB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E350058-4AB6-E952-E8EE-C7043A78AE8D}"/>
              </a:ext>
            </a:extLst>
          </p:cNvPr>
          <p:cNvSpPr txBox="1"/>
          <p:nvPr/>
        </p:nvSpPr>
        <p:spPr>
          <a:xfrm rot="18594304">
            <a:off x="7774098" y="1099121"/>
            <a:ext cx="10755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sz="1600" b="1" dirty="0"/>
              <a:t>Gal-3+PF</a:t>
            </a:r>
            <a:endParaRPr lang="en-GB" sz="1600" b="1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A91CDB4-2517-11A3-A7C0-44D91AA47F85}"/>
              </a:ext>
            </a:extLst>
          </p:cNvPr>
          <p:cNvSpPr txBox="1"/>
          <p:nvPr/>
        </p:nvSpPr>
        <p:spPr>
          <a:xfrm rot="18594304">
            <a:off x="8304713" y="918238"/>
            <a:ext cx="10872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SB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3976842-4947-C974-A949-F2346132C64E}"/>
              </a:ext>
            </a:extLst>
          </p:cNvPr>
          <p:cNvSpPr txBox="1"/>
          <p:nvPr/>
        </p:nvSpPr>
        <p:spPr>
          <a:xfrm rot="18594304">
            <a:off x="8769569" y="924551"/>
            <a:ext cx="10708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sz="1600" b="1" dirty="0"/>
              <a:t>PF</a:t>
            </a:r>
            <a:endParaRPr lang="en-GB" sz="1600" b="1" dirty="0"/>
          </a:p>
        </p:txBody>
      </p:sp>
    </p:spTree>
    <p:extLst>
      <p:ext uri="{BB962C8B-B14F-4D97-AF65-F5344CB8AC3E}">
        <p14:creationId xmlns:p14="http://schemas.microsoft.com/office/powerpoint/2010/main" val="197468594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7DE1DD6-2B71-4268-F85A-AD065B64F21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0308" t="19827" r="40560" b="35482"/>
          <a:stretch/>
        </p:blipFill>
        <p:spPr>
          <a:xfrm>
            <a:off x="3415004" y="1593905"/>
            <a:ext cx="2332653" cy="271803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2E053FEA-1535-5A8B-D7AD-C6499B42B57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3903" t="23318" r="34494" b="24124"/>
          <a:stretch/>
        </p:blipFill>
        <p:spPr>
          <a:xfrm>
            <a:off x="5952931" y="1593908"/>
            <a:ext cx="2332653" cy="271803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24ABBFA-093A-2373-2164-3AB878BECC0B}"/>
              </a:ext>
            </a:extLst>
          </p:cNvPr>
          <p:cNvSpPr txBox="1"/>
          <p:nvPr/>
        </p:nvSpPr>
        <p:spPr>
          <a:xfrm>
            <a:off x="1472311" y="2749492"/>
            <a:ext cx="16014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+mj-lt"/>
              </a:rPr>
              <a:t>Phospho-STAT1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B090B121-37C7-E1D7-3587-2471C5F434F0}"/>
              </a:ext>
            </a:extLst>
          </p:cNvPr>
          <p:cNvCxnSpPr/>
          <p:nvPr/>
        </p:nvCxnSpPr>
        <p:spPr>
          <a:xfrm>
            <a:off x="2952924" y="2934158"/>
            <a:ext cx="42783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A916E2BC-B312-7397-5D8D-D5CBCF53035B}"/>
              </a:ext>
            </a:extLst>
          </p:cNvPr>
          <p:cNvSpPr txBox="1"/>
          <p:nvPr/>
        </p:nvSpPr>
        <p:spPr>
          <a:xfrm>
            <a:off x="8699384" y="2615160"/>
            <a:ext cx="7229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+mj-lt"/>
              </a:rPr>
              <a:t>STAT1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60D1560F-619D-CAB7-3A54-6F45CA9AECAF}"/>
              </a:ext>
            </a:extLst>
          </p:cNvPr>
          <p:cNvCxnSpPr>
            <a:stCxn id="10" idx="1"/>
          </p:cNvCxnSpPr>
          <p:nvPr/>
        </p:nvCxnSpPr>
        <p:spPr>
          <a:xfrm flipH="1">
            <a:off x="8254767" y="2799826"/>
            <a:ext cx="44461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B4099ADC-7EBB-9E2F-AB5E-2B8CE6A1E95F}"/>
              </a:ext>
            </a:extLst>
          </p:cNvPr>
          <p:cNvSpPr txBox="1"/>
          <p:nvPr/>
        </p:nvSpPr>
        <p:spPr>
          <a:xfrm rot="18594304">
            <a:off x="3213957" y="1194635"/>
            <a:ext cx="13341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C</a:t>
            </a:r>
            <a:r>
              <a:rPr lang="en-US" altLang="zh-CN" sz="1600" b="1" dirty="0"/>
              <a:t>on</a:t>
            </a:r>
            <a:endParaRPr lang="en-GB" sz="1600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AA51255-A954-7C8B-04DF-CF697E73D1D7}"/>
              </a:ext>
            </a:extLst>
          </p:cNvPr>
          <p:cNvSpPr txBox="1"/>
          <p:nvPr/>
        </p:nvSpPr>
        <p:spPr>
          <a:xfrm rot="18721435">
            <a:off x="3628667" y="1110312"/>
            <a:ext cx="15919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Gal-3</a:t>
            </a:r>
            <a:endParaRPr lang="en-GB" sz="1600" b="1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FE5FC1A-95B1-2C7F-A349-BAF828A6FD87}"/>
              </a:ext>
            </a:extLst>
          </p:cNvPr>
          <p:cNvSpPr txBox="1"/>
          <p:nvPr/>
        </p:nvSpPr>
        <p:spPr>
          <a:xfrm rot="18594304">
            <a:off x="4003573" y="1283286"/>
            <a:ext cx="13146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Gal-3+S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23F0893-9C10-F21E-596A-D56767CEFD4E}"/>
              </a:ext>
            </a:extLst>
          </p:cNvPr>
          <p:cNvSpPr txBox="1"/>
          <p:nvPr/>
        </p:nvSpPr>
        <p:spPr>
          <a:xfrm rot="18594304">
            <a:off x="4498710" y="1303816"/>
            <a:ext cx="10755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sz="1600" b="1" dirty="0"/>
              <a:t>Gal-3+PF</a:t>
            </a:r>
            <a:endParaRPr lang="en-GB" sz="1600" b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92FD967-BF0F-6C24-6AA9-598F6AB507BD}"/>
              </a:ext>
            </a:extLst>
          </p:cNvPr>
          <p:cNvSpPr txBox="1"/>
          <p:nvPr/>
        </p:nvSpPr>
        <p:spPr>
          <a:xfrm rot="18594304">
            <a:off x="4920268" y="1122933"/>
            <a:ext cx="10872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SB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2503F5E-C5FC-2C38-8F89-760296F2B8E1}"/>
              </a:ext>
            </a:extLst>
          </p:cNvPr>
          <p:cNvSpPr txBox="1"/>
          <p:nvPr/>
        </p:nvSpPr>
        <p:spPr>
          <a:xfrm rot="18594304">
            <a:off x="5267678" y="1129246"/>
            <a:ext cx="10708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sz="1600" b="1" dirty="0"/>
              <a:t>PF</a:t>
            </a:r>
            <a:endParaRPr lang="en-GB" sz="1600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E10BC32-8F6B-3408-B4DC-56D057C0C800}"/>
              </a:ext>
            </a:extLst>
          </p:cNvPr>
          <p:cNvSpPr txBox="1"/>
          <p:nvPr/>
        </p:nvSpPr>
        <p:spPr>
          <a:xfrm rot="18594304">
            <a:off x="5833249" y="1109115"/>
            <a:ext cx="13341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C</a:t>
            </a:r>
            <a:r>
              <a:rPr lang="en-US" altLang="zh-CN" sz="1600" b="1" dirty="0"/>
              <a:t>on</a:t>
            </a:r>
            <a:endParaRPr lang="en-GB" sz="1600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4D390FA-F106-02A9-625A-E14B29E9185C}"/>
              </a:ext>
            </a:extLst>
          </p:cNvPr>
          <p:cNvSpPr txBox="1"/>
          <p:nvPr/>
        </p:nvSpPr>
        <p:spPr>
          <a:xfrm rot="18721435">
            <a:off x="6122536" y="1024792"/>
            <a:ext cx="15919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Gal-3</a:t>
            </a:r>
            <a:endParaRPr lang="en-GB" sz="1600" b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43A2A60-2435-8A5B-B593-31C0489AC8F6}"/>
              </a:ext>
            </a:extLst>
          </p:cNvPr>
          <p:cNvSpPr txBox="1"/>
          <p:nvPr/>
        </p:nvSpPr>
        <p:spPr>
          <a:xfrm rot="18594304">
            <a:off x="6586579" y="1091639"/>
            <a:ext cx="13146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Gal-3+SB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8B54A19-6B4B-D896-BF4F-532B4CDFFBBC}"/>
              </a:ext>
            </a:extLst>
          </p:cNvPr>
          <p:cNvSpPr txBox="1"/>
          <p:nvPr/>
        </p:nvSpPr>
        <p:spPr>
          <a:xfrm rot="18594304">
            <a:off x="6980447" y="1143289"/>
            <a:ext cx="10755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sz="1600" b="1" dirty="0"/>
              <a:t>Gal-3+PF</a:t>
            </a:r>
            <a:endParaRPr lang="en-GB" sz="1600" b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BE96085-F7D5-F6CB-9107-67E473C20B60}"/>
              </a:ext>
            </a:extLst>
          </p:cNvPr>
          <p:cNvSpPr txBox="1"/>
          <p:nvPr/>
        </p:nvSpPr>
        <p:spPr>
          <a:xfrm rot="18594304">
            <a:off x="7372475" y="1107728"/>
            <a:ext cx="10872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SB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D3C4B3C-9522-8B99-7EFB-8C72544F681F}"/>
              </a:ext>
            </a:extLst>
          </p:cNvPr>
          <p:cNvSpPr txBox="1"/>
          <p:nvPr/>
        </p:nvSpPr>
        <p:spPr>
          <a:xfrm rot="18594304">
            <a:off x="7719350" y="1081566"/>
            <a:ext cx="10708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sz="1600" b="1" dirty="0"/>
              <a:t>PF</a:t>
            </a:r>
            <a:endParaRPr lang="en-GB" sz="1600" b="1" dirty="0"/>
          </a:p>
        </p:txBody>
      </p:sp>
    </p:spTree>
    <p:extLst>
      <p:ext uri="{BB962C8B-B14F-4D97-AF65-F5344CB8AC3E}">
        <p14:creationId xmlns:p14="http://schemas.microsoft.com/office/powerpoint/2010/main" val="312476806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0A403AF-D942-70BB-942F-6639D22749A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8188" t="13896" r="38241" b="28483"/>
          <a:stretch/>
        </p:blipFill>
        <p:spPr>
          <a:xfrm>
            <a:off x="2761862" y="1233182"/>
            <a:ext cx="2873828" cy="350448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012DFDF-379E-79A1-C108-EF2E53106CC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8738" t="22862" r="38486" b="18307"/>
          <a:stretch/>
        </p:blipFill>
        <p:spPr>
          <a:xfrm>
            <a:off x="5635690" y="1233182"/>
            <a:ext cx="2776756" cy="357801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FE504D5-973E-AB9A-113F-7D48B860C25A}"/>
              </a:ext>
            </a:extLst>
          </p:cNvPr>
          <p:cNvSpPr txBox="1"/>
          <p:nvPr/>
        </p:nvSpPr>
        <p:spPr>
          <a:xfrm>
            <a:off x="684997" y="2856287"/>
            <a:ext cx="171874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+mj-lt"/>
              </a:rPr>
              <a:t>Phospho-GSK3</a:t>
            </a:r>
            <a:r>
              <a:rPr lang="el-GR" dirty="0">
                <a:latin typeface="+mj-lt"/>
              </a:rPr>
              <a:t>α</a:t>
            </a:r>
            <a:endParaRPr lang="en-GB" dirty="0">
              <a:latin typeface="+mj-lt"/>
            </a:endParaRPr>
          </a:p>
          <a:p>
            <a:r>
              <a:rPr lang="en-GB" dirty="0">
                <a:latin typeface="+mj-lt"/>
              </a:rPr>
              <a:t>Phospho-GSK3</a:t>
            </a:r>
            <a:r>
              <a:rPr lang="el-GR" dirty="0">
                <a:latin typeface="+mj-lt"/>
              </a:rPr>
              <a:t>β</a:t>
            </a:r>
            <a:endParaRPr lang="en-GB" dirty="0">
              <a:latin typeface="+mj-lt"/>
            </a:endParaRP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2E6306E3-C1FB-7E9A-9D7B-C2C1CDEC5695}"/>
              </a:ext>
            </a:extLst>
          </p:cNvPr>
          <p:cNvCxnSpPr/>
          <p:nvPr/>
        </p:nvCxnSpPr>
        <p:spPr>
          <a:xfrm>
            <a:off x="2288062" y="3040953"/>
            <a:ext cx="473800" cy="7136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9831759A-95A6-DE3B-6640-1BDA62FD3341}"/>
              </a:ext>
            </a:extLst>
          </p:cNvPr>
          <p:cNvCxnSpPr/>
          <p:nvPr/>
        </p:nvCxnSpPr>
        <p:spPr>
          <a:xfrm flipV="1">
            <a:off x="2288062" y="3288484"/>
            <a:ext cx="473800" cy="6711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9E2C7D8B-4EF9-9A2B-05C2-4A1842DB8C9C}"/>
              </a:ext>
            </a:extLst>
          </p:cNvPr>
          <p:cNvSpPr txBox="1"/>
          <p:nvPr/>
        </p:nvSpPr>
        <p:spPr>
          <a:xfrm>
            <a:off x="8855806" y="2856287"/>
            <a:ext cx="79541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+mj-lt"/>
              </a:rPr>
              <a:t>GSK3</a:t>
            </a:r>
            <a:r>
              <a:rPr lang="el-GR" dirty="0">
                <a:latin typeface="+mj-lt"/>
              </a:rPr>
              <a:t>α</a:t>
            </a:r>
            <a:endParaRPr lang="en-GB" dirty="0">
              <a:latin typeface="+mj-lt"/>
            </a:endParaRPr>
          </a:p>
          <a:p>
            <a:r>
              <a:rPr lang="en-GB" dirty="0">
                <a:latin typeface="+mj-lt"/>
              </a:rPr>
              <a:t>GSK3</a:t>
            </a:r>
            <a:r>
              <a:rPr lang="el-GR" dirty="0">
                <a:latin typeface="+mj-lt"/>
              </a:rPr>
              <a:t>β</a:t>
            </a:r>
            <a:endParaRPr lang="en-GB" dirty="0">
              <a:latin typeface="+mj-lt"/>
            </a:endParaRP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FC4D8ED2-508A-C4B5-0163-DDA5D5D27BD5}"/>
              </a:ext>
            </a:extLst>
          </p:cNvPr>
          <p:cNvCxnSpPr>
            <a:cxnSpLocks/>
          </p:cNvCxnSpPr>
          <p:nvPr/>
        </p:nvCxnSpPr>
        <p:spPr>
          <a:xfrm flipH="1">
            <a:off x="8412446" y="3011648"/>
            <a:ext cx="438994" cy="13849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E32C46CE-E35B-D911-958E-9FD5261F8A3D}"/>
              </a:ext>
            </a:extLst>
          </p:cNvPr>
          <p:cNvCxnSpPr/>
          <p:nvPr/>
        </p:nvCxnSpPr>
        <p:spPr>
          <a:xfrm flipH="1">
            <a:off x="8457187" y="3326291"/>
            <a:ext cx="39861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877AAFFE-4C5B-A41D-E630-6685DFE2F727}"/>
              </a:ext>
            </a:extLst>
          </p:cNvPr>
          <p:cNvSpPr txBox="1"/>
          <p:nvPr/>
        </p:nvSpPr>
        <p:spPr>
          <a:xfrm rot="18594304">
            <a:off x="2652268" y="1330741"/>
            <a:ext cx="13341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C</a:t>
            </a:r>
            <a:r>
              <a:rPr lang="en-US" altLang="zh-CN" sz="1600" b="1" dirty="0"/>
              <a:t>on</a:t>
            </a:r>
            <a:endParaRPr lang="en-GB" sz="1600" b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B93A920-2142-1DDB-8D6A-5C5C8C7DE9A1}"/>
              </a:ext>
            </a:extLst>
          </p:cNvPr>
          <p:cNvSpPr txBox="1"/>
          <p:nvPr/>
        </p:nvSpPr>
        <p:spPr>
          <a:xfrm rot="18721435">
            <a:off x="3100534" y="1246418"/>
            <a:ext cx="15919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Gal-3</a:t>
            </a:r>
            <a:endParaRPr lang="en-GB" sz="1600" b="1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704831C-EDFB-048B-2B73-F9689AB952FA}"/>
              </a:ext>
            </a:extLst>
          </p:cNvPr>
          <p:cNvSpPr txBox="1"/>
          <p:nvPr/>
        </p:nvSpPr>
        <p:spPr>
          <a:xfrm rot="18594304">
            <a:off x="3576108" y="1419392"/>
            <a:ext cx="13146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Gal-3+S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CD5A125-FDBC-6677-D29B-660BD091D1BB}"/>
              </a:ext>
            </a:extLst>
          </p:cNvPr>
          <p:cNvSpPr txBox="1"/>
          <p:nvPr/>
        </p:nvSpPr>
        <p:spPr>
          <a:xfrm rot="18594304">
            <a:off x="4104801" y="1439922"/>
            <a:ext cx="10755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sz="1600" b="1" dirty="0"/>
              <a:t>Gal-3+PF</a:t>
            </a:r>
            <a:endParaRPr lang="en-GB" sz="1600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E89F4A6-18D3-A6E9-5F6D-BA363CDD3A6D}"/>
              </a:ext>
            </a:extLst>
          </p:cNvPr>
          <p:cNvSpPr txBox="1"/>
          <p:nvPr/>
        </p:nvSpPr>
        <p:spPr>
          <a:xfrm rot="18594304">
            <a:off x="4635416" y="1259039"/>
            <a:ext cx="10872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SB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7B64E59-D5FE-DFBA-69CF-7B3ACD33A71F}"/>
              </a:ext>
            </a:extLst>
          </p:cNvPr>
          <p:cNvSpPr txBox="1"/>
          <p:nvPr/>
        </p:nvSpPr>
        <p:spPr>
          <a:xfrm rot="18594304">
            <a:off x="5033264" y="1272944"/>
            <a:ext cx="10708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sz="1600" b="1" dirty="0"/>
              <a:t>PF</a:t>
            </a:r>
            <a:endParaRPr lang="en-GB" sz="1600" b="1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0526C7F-F9D5-5E4E-5220-6863C8403E46}"/>
              </a:ext>
            </a:extLst>
          </p:cNvPr>
          <p:cNvSpPr txBox="1"/>
          <p:nvPr/>
        </p:nvSpPr>
        <p:spPr>
          <a:xfrm rot="18594304">
            <a:off x="5571316" y="1176027"/>
            <a:ext cx="13341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C</a:t>
            </a:r>
            <a:r>
              <a:rPr lang="en-US" altLang="zh-CN" sz="1600" b="1" dirty="0"/>
              <a:t>on</a:t>
            </a:r>
            <a:endParaRPr lang="en-GB" sz="1600" b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460BE7B-0957-B52C-9062-38D1F295E194}"/>
              </a:ext>
            </a:extLst>
          </p:cNvPr>
          <p:cNvSpPr txBox="1"/>
          <p:nvPr/>
        </p:nvSpPr>
        <p:spPr>
          <a:xfrm rot="18721435">
            <a:off x="6019582" y="1091704"/>
            <a:ext cx="15919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Gal-3</a:t>
            </a:r>
            <a:endParaRPr lang="en-GB" sz="1600" b="1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5AD430F-88E8-3102-0EA5-FF26060D76E8}"/>
              </a:ext>
            </a:extLst>
          </p:cNvPr>
          <p:cNvSpPr txBox="1"/>
          <p:nvPr/>
        </p:nvSpPr>
        <p:spPr>
          <a:xfrm rot="18594304">
            <a:off x="6495156" y="1264678"/>
            <a:ext cx="13146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Gal-3+SB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43AEE1D-E8FB-6442-4C2F-EC72D2FDD28F}"/>
              </a:ext>
            </a:extLst>
          </p:cNvPr>
          <p:cNvSpPr txBox="1"/>
          <p:nvPr/>
        </p:nvSpPr>
        <p:spPr>
          <a:xfrm rot="18594304">
            <a:off x="7023849" y="1285208"/>
            <a:ext cx="10755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sz="1600" b="1" dirty="0"/>
              <a:t>Gal-3+PF</a:t>
            </a:r>
            <a:endParaRPr lang="en-GB" sz="1600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6D66732-C53B-08FC-FBF7-E99308634958}"/>
              </a:ext>
            </a:extLst>
          </p:cNvPr>
          <p:cNvSpPr txBox="1"/>
          <p:nvPr/>
        </p:nvSpPr>
        <p:spPr>
          <a:xfrm rot="18594304">
            <a:off x="7511163" y="1113375"/>
            <a:ext cx="10872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SB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ACD857B-66A2-7672-2687-771F903C8F42}"/>
              </a:ext>
            </a:extLst>
          </p:cNvPr>
          <p:cNvSpPr txBox="1"/>
          <p:nvPr/>
        </p:nvSpPr>
        <p:spPr>
          <a:xfrm rot="18594304">
            <a:off x="7917206" y="1110639"/>
            <a:ext cx="10708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sz="1600" b="1" dirty="0"/>
              <a:t>PF</a:t>
            </a:r>
            <a:endParaRPr lang="en-GB" sz="1600" b="1" dirty="0"/>
          </a:p>
        </p:txBody>
      </p:sp>
    </p:spTree>
    <p:extLst>
      <p:ext uri="{BB962C8B-B14F-4D97-AF65-F5344CB8AC3E}">
        <p14:creationId xmlns:p14="http://schemas.microsoft.com/office/powerpoint/2010/main" val="71815287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9C78CD0E-5DAC-F4B1-1363-021F55CE31E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7875" t="2966" r="27799" b="31575"/>
          <a:stretch/>
        </p:blipFill>
        <p:spPr>
          <a:xfrm>
            <a:off x="6057189" y="1239197"/>
            <a:ext cx="2945430" cy="304757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31525A5-FD0F-335A-B473-16B57E4B2EF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7410" t="15840" r="56968" b="29302"/>
          <a:stretch/>
        </p:blipFill>
        <p:spPr>
          <a:xfrm>
            <a:off x="2740765" y="1239197"/>
            <a:ext cx="3125756" cy="3047577"/>
          </a:xfrm>
          <a:prstGeom prst="rect">
            <a:avLst/>
          </a:prstGeom>
          <a:ln>
            <a:noFill/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884980B9-C311-5C69-D4F7-3F28451E256E}"/>
              </a:ext>
            </a:extLst>
          </p:cNvPr>
          <p:cNvSpPr txBox="1"/>
          <p:nvPr/>
        </p:nvSpPr>
        <p:spPr>
          <a:xfrm>
            <a:off x="706422" y="2403421"/>
            <a:ext cx="16014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+mj-lt"/>
              </a:rPr>
              <a:t>Phospho-STAT3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3DD53FEC-250E-A62E-3682-14EFABCC7818}"/>
              </a:ext>
            </a:extLst>
          </p:cNvPr>
          <p:cNvCxnSpPr>
            <a:stCxn id="8" idx="3"/>
          </p:cNvCxnSpPr>
          <p:nvPr/>
        </p:nvCxnSpPr>
        <p:spPr>
          <a:xfrm>
            <a:off x="2307822" y="2588087"/>
            <a:ext cx="447286" cy="6473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A8883C7D-8E43-FCB6-8DD9-499EAA7A0BF9}"/>
              </a:ext>
            </a:extLst>
          </p:cNvPr>
          <p:cNvSpPr txBox="1"/>
          <p:nvPr/>
        </p:nvSpPr>
        <p:spPr>
          <a:xfrm>
            <a:off x="9193287" y="2403421"/>
            <a:ext cx="7229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+mj-lt"/>
              </a:rPr>
              <a:t>STAT3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AEE4527E-2570-084B-04E6-44C133303818}"/>
              </a:ext>
            </a:extLst>
          </p:cNvPr>
          <p:cNvCxnSpPr>
            <a:stCxn id="10" idx="1"/>
          </p:cNvCxnSpPr>
          <p:nvPr/>
        </p:nvCxnSpPr>
        <p:spPr>
          <a:xfrm flipH="1">
            <a:off x="8975485" y="2588087"/>
            <a:ext cx="21780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4E25DF6A-64A8-57A4-DA75-53AEA540C2C4}"/>
              </a:ext>
            </a:extLst>
          </p:cNvPr>
          <p:cNvSpPr txBox="1"/>
          <p:nvPr/>
        </p:nvSpPr>
        <p:spPr>
          <a:xfrm rot="18594304">
            <a:off x="2868726" y="1283163"/>
            <a:ext cx="13341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C</a:t>
            </a:r>
            <a:r>
              <a:rPr lang="en-US" altLang="zh-CN" sz="1600" b="1" dirty="0"/>
              <a:t>on</a:t>
            </a:r>
            <a:endParaRPr lang="en-GB" sz="1600" b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3F71FFC-4E31-A064-BEF2-B56553467278}"/>
              </a:ext>
            </a:extLst>
          </p:cNvPr>
          <p:cNvSpPr txBox="1"/>
          <p:nvPr/>
        </p:nvSpPr>
        <p:spPr>
          <a:xfrm rot="18721435">
            <a:off x="3316992" y="1198840"/>
            <a:ext cx="15919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Gal-3</a:t>
            </a:r>
            <a:endParaRPr lang="en-GB" sz="1600" b="1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FED85A5-ADA5-770C-B569-D15785C8B116}"/>
              </a:ext>
            </a:extLst>
          </p:cNvPr>
          <p:cNvSpPr txBox="1"/>
          <p:nvPr/>
        </p:nvSpPr>
        <p:spPr>
          <a:xfrm rot="18594304">
            <a:off x="3792566" y="1371814"/>
            <a:ext cx="13146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Gal-3+SB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11DEBDD-758A-F1D2-F870-41FC2279B421}"/>
              </a:ext>
            </a:extLst>
          </p:cNvPr>
          <p:cNvSpPr txBox="1"/>
          <p:nvPr/>
        </p:nvSpPr>
        <p:spPr>
          <a:xfrm rot="18594304">
            <a:off x="4321259" y="1392344"/>
            <a:ext cx="10755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sz="1600" b="1" dirty="0"/>
              <a:t>Gal-3+PF</a:t>
            </a:r>
            <a:endParaRPr lang="en-GB" sz="1600" b="1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1609042-719D-A11F-3923-8AF23B59F908}"/>
              </a:ext>
            </a:extLst>
          </p:cNvPr>
          <p:cNvSpPr txBox="1"/>
          <p:nvPr/>
        </p:nvSpPr>
        <p:spPr>
          <a:xfrm rot="18594304">
            <a:off x="4851874" y="1211461"/>
            <a:ext cx="10872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SB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06767BB-B1A6-A47C-E4B2-63B954F9CDF2}"/>
              </a:ext>
            </a:extLst>
          </p:cNvPr>
          <p:cNvSpPr txBox="1"/>
          <p:nvPr/>
        </p:nvSpPr>
        <p:spPr>
          <a:xfrm rot="18594304">
            <a:off x="5316730" y="1217774"/>
            <a:ext cx="10708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sz="1600" b="1" dirty="0"/>
              <a:t>PF</a:t>
            </a:r>
            <a:endParaRPr lang="en-GB" sz="1600" b="1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DCDCC2B-B586-BB1B-091A-47136963A444}"/>
              </a:ext>
            </a:extLst>
          </p:cNvPr>
          <p:cNvSpPr txBox="1"/>
          <p:nvPr/>
        </p:nvSpPr>
        <p:spPr>
          <a:xfrm rot="18594304">
            <a:off x="6019198" y="1335188"/>
            <a:ext cx="13341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C</a:t>
            </a:r>
            <a:r>
              <a:rPr lang="en-US" altLang="zh-CN" sz="1600" b="1" dirty="0"/>
              <a:t>on</a:t>
            </a:r>
            <a:endParaRPr lang="en-GB" sz="1600" b="1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246BF13-D22E-6DF9-7226-F067EF741653}"/>
              </a:ext>
            </a:extLst>
          </p:cNvPr>
          <p:cNvSpPr txBox="1"/>
          <p:nvPr/>
        </p:nvSpPr>
        <p:spPr>
          <a:xfrm rot="18721435">
            <a:off x="6467464" y="1250865"/>
            <a:ext cx="15919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Gal-3</a:t>
            </a:r>
            <a:endParaRPr lang="en-GB" sz="1600" b="1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EC46F69-E286-1632-47DC-01BAA6DD3A32}"/>
              </a:ext>
            </a:extLst>
          </p:cNvPr>
          <p:cNvSpPr txBox="1"/>
          <p:nvPr/>
        </p:nvSpPr>
        <p:spPr>
          <a:xfrm rot="18594304">
            <a:off x="6943038" y="1423839"/>
            <a:ext cx="13146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Gal-3+SB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A83A4D3-1262-AD47-60BB-ADB6B6A16615}"/>
              </a:ext>
            </a:extLst>
          </p:cNvPr>
          <p:cNvSpPr txBox="1"/>
          <p:nvPr/>
        </p:nvSpPr>
        <p:spPr>
          <a:xfrm rot="18594304">
            <a:off x="7471731" y="1444369"/>
            <a:ext cx="10755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sz="1600" b="1" dirty="0"/>
              <a:t>Gal-3+PF</a:t>
            </a:r>
            <a:endParaRPr lang="en-GB" sz="1600" b="1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8EC3AB3-0505-339D-79F6-A98E3C2A5969}"/>
              </a:ext>
            </a:extLst>
          </p:cNvPr>
          <p:cNvSpPr txBox="1"/>
          <p:nvPr/>
        </p:nvSpPr>
        <p:spPr>
          <a:xfrm rot="18594304">
            <a:off x="8002346" y="1263486"/>
            <a:ext cx="10872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SB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A308E7E-A336-2AC0-7DC0-F5E52076FA45}"/>
              </a:ext>
            </a:extLst>
          </p:cNvPr>
          <p:cNvSpPr txBox="1"/>
          <p:nvPr/>
        </p:nvSpPr>
        <p:spPr>
          <a:xfrm rot="18594304">
            <a:off x="8467202" y="1269799"/>
            <a:ext cx="10708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sz="1600" b="1" dirty="0"/>
              <a:t>PF</a:t>
            </a:r>
            <a:endParaRPr lang="en-GB" sz="1600" b="1" dirty="0"/>
          </a:p>
        </p:txBody>
      </p:sp>
    </p:spTree>
    <p:extLst>
      <p:ext uri="{BB962C8B-B14F-4D97-AF65-F5344CB8AC3E}">
        <p14:creationId xmlns:p14="http://schemas.microsoft.com/office/powerpoint/2010/main" val="31048439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1</TotalTime>
  <Words>196</Words>
  <Application>Microsoft Office PowerPoint</Application>
  <PresentationFormat>Widescreen</PresentationFormat>
  <Paragraphs>76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等线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, Shun [sl210]</dc:creator>
  <cp:lastModifiedBy>Yu, Lu-Gang</cp:lastModifiedBy>
  <cp:revision>2</cp:revision>
  <dcterms:created xsi:type="dcterms:W3CDTF">2022-12-13T11:57:02Z</dcterms:created>
  <dcterms:modified xsi:type="dcterms:W3CDTF">2022-12-24T18:00:44Z</dcterms:modified>
</cp:coreProperties>
</file>